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65" r:id="rId2"/>
  </p:sldIdLst>
  <p:sldSz cx="12192000" cy="6858000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=""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yle moyen 2 - Accentuation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995" autoAdjust="0"/>
    <p:restoredTop sz="94660"/>
  </p:normalViewPr>
  <p:slideViewPr>
    <p:cSldViewPr snapToGrid="0">
      <p:cViewPr>
        <p:scale>
          <a:sx n="90" d="100"/>
          <a:sy n="90" d="100"/>
        </p:scale>
        <p:origin x="-1440" y="-690"/>
      </p:cViewPr>
      <p:guideLst>
        <p:guide orient="horz" pos="492"/>
        <p:guide pos="425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en-têt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D8EA8D9-AA9B-44B4-8D43-3BEA004884AE}" type="datetimeFigureOut">
              <a:rPr lang="fr-FR" smtClean="0"/>
              <a:t>01/06/2021</a:t>
            </a:fld>
            <a:endParaRPr lang="fr-FR"/>
          </a:p>
        </p:txBody>
      </p:sp>
      <p:sp>
        <p:nvSpPr>
          <p:cNvPr id="4" name="Espace réservé de l'image des diapositives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fr-FR"/>
          </a:p>
        </p:txBody>
      </p:sp>
      <p:sp>
        <p:nvSpPr>
          <p:cNvPr id="5" name="Espace réservé des notes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DBFD854-18DF-40D9-9249-A1F26EB5D596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92592539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fr-FR" smtClean="0"/>
              <a:t>Modifier le style des sous-titres du masque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459E2F-094B-4455-AF32-DDF2BABC094A}" type="datetimeFigureOut">
              <a:rPr lang="fr-FR" smtClean="0"/>
              <a:t>01/06/2021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7E12EC-9BEB-4EC9-BC91-5BF77F9BC3C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70831367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459E2F-094B-4455-AF32-DDF2BABC094A}" type="datetimeFigureOut">
              <a:rPr lang="fr-FR" smtClean="0"/>
              <a:t>01/06/2021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7E12EC-9BEB-4EC9-BC91-5BF77F9BC3C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71276850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459E2F-094B-4455-AF32-DDF2BABC094A}" type="datetimeFigureOut">
              <a:rPr lang="fr-FR" smtClean="0"/>
              <a:t>01/06/2021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7E12EC-9BEB-4EC9-BC91-5BF77F9BC3C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57201109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459E2F-094B-4455-AF32-DDF2BABC094A}" type="datetimeFigureOut">
              <a:rPr lang="fr-FR" smtClean="0"/>
              <a:t>01/06/2021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7E12EC-9BEB-4EC9-BC91-5BF77F9BC3C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711072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459E2F-094B-4455-AF32-DDF2BABC094A}" type="datetimeFigureOut">
              <a:rPr lang="fr-FR" smtClean="0"/>
              <a:t>01/06/2021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7E12EC-9BEB-4EC9-BC91-5BF77F9BC3C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2003916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459E2F-094B-4455-AF32-DDF2BABC094A}" type="datetimeFigureOut">
              <a:rPr lang="fr-FR" smtClean="0"/>
              <a:t>01/06/2021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7E12EC-9BEB-4EC9-BC91-5BF77F9BC3C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57258014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459E2F-094B-4455-AF32-DDF2BABC094A}" type="datetimeFigureOut">
              <a:rPr lang="fr-FR" smtClean="0"/>
              <a:t>01/06/2021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7E12EC-9BEB-4EC9-BC91-5BF77F9BC3C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03458050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459E2F-094B-4455-AF32-DDF2BABC094A}" type="datetimeFigureOut">
              <a:rPr lang="fr-FR" smtClean="0"/>
              <a:t>01/06/2021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7E12EC-9BEB-4EC9-BC91-5BF77F9BC3C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70792747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459E2F-094B-4455-AF32-DDF2BABC094A}" type="datetimeFigureOut">
              <a:rPr lang="fr-FR" smtClean="0"/>
              <a:t>01/06/2021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7E12EC-9BEB-4EC9-BC91-5BF77F9BC3C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63070716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459E2F-094B-4455-AF32-DDF2BABC094A}" type="datetimeFigureOut">
              <a:rPr lang="fr-FR" smtClean="0"/>
              <a:t>01/06/2021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7E12EC-9BEB-4EC9-BC91-5BF77F9BC3C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38236862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459E2F-094B-4455-AF32-DDF2BABC094A}" type="datetimeFigureOut">
              <a:rPr lang="fr-FR" smtClean="0"/>
              <a:t>01/06/2021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7E12EC-9BEB-4EC9-BC91-5BF77F9BC3C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68246432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E459E2F-094B-4455-AF32-DDF2BABC094A}" type="datetimeFigureOut">
              <a:rPr lang="fr-FR" smtClean="0"/>
              <a:t>01/06/2021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B7E12EC-9BEB-4EC9-BC91-5BF77F9BC3C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27699576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au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555988126"/>
              </p:ext>
            </p:extLst>
          </p:nvPr>
        </p:nvGraphicFramePr>
        <p:xfrm>
          <a:off x="932069" y="2199165"/>
          <a:ext cx="9826074" cy="2348298"/>
        </p:xfrm>
        <a:graphic>
          <a:graphicData uri="http://schemas.openxmlformats.org/drawingml/2006/table">
            <a:tbl>
              <a:tblPr firstRow="1" firstCol="1" bandRow="1">
                <a:tableStyleId>{5C22544A-7EE6-4342-B048-85BDC9FD1C3A}</a:tableStyleId>
              </a:tblPr>
              <a:tblGrid>
                <a:gridCol w="1664322">
                  <a:extLst>
                    <a:ext uri="{9D8B030D-6E8A-4147-A177-3AD203B41FA5}">
                      <a16:colId xmlns="" xmlns:a16="http://schemas.microsoft.com/office/drawing/2014/main" val="1032064062"/>
                    </a:ext>
                  </a:extLst>
                </a:gridCol>
                <a:gridCol w="1857848">
                  <a:extLst>
                    <a:ext uri="{9D8B030D-6E8A-4147-A177-3AD203B41FA5}">
                      <a16:colId xmlns="" xmlns:a16="http://schemas.microsoft.com/office/drawing/2014/main" val="3101142915"/>
                    </a:ext>
                  </a:extLst>
                </a:gridCol>
                <a:gridCol w="3151952">
                  <a:extLst>
                    <a:ext uri="{9D8B030D-6E8A-4147-A177-3AD203B41FA5}">
                      <a16:colId xmlns="" xmlns:a16="http://schemas.microsoft.com/office/drawing/2014/main" val="1343062688"/>
                    </a:ext>
                  </a:extLst>
                </a:gridCol>
                <a:gridCol w="3151952">
                  <a:extLst>
                    <a:ext uri="{9D8B030D-6E8A-4147-A177-3AD203B41FA5}">
                      <a16:colId xmlns="" xmlns:a16="http://schemas.microsoft.com/office/drawing/2014/main" val="2256968657"/>
                    </a:ext>
                  </a:extLst>
                </a:gridCol>
              </a:tblGrid>
              <a:tr h="165257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600" cap="all" dirty="0">
                          <a:solidFill>
                            <a:schemeClr val="tx1"/>
                          </a:solidFill>
                          <a:effectLst/>
                        </a:rPr>
                        <a:t>Model</a:t>
                      </a:r>
                      <a:endParaRPr lang="fr-FR" sz="16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74755" marR="74755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600" cap="all" dirty="0" smtClean="0">
                          <a:solidFill>
                            <a:schemeClr val="tx1"/>
                          </a:solidFill>
                          <a:effectLst/>
                        </a:rPr>
                        <a:t>BAPN</a:t>
                      </a:r>
                      <a:endParaRPr lang="fr-FR" sz="16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74755" marR="74755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600" cap="all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Collagen</a:t>
                      </a:r>
                      <a:r>
                        <a:rPr lang="en-US" sz="1600" cap="all" baseline="0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fiber width (</a:t>
                      </a:r>
                      <a:r>
                        <a:rPr lang="en-US" sz="1600" cap="all" baseline="0" dirty="0" smtClean="0">
                          <a:solidFill>
                            <a:schemeClr val="tx1"/>
                          </a:solidFill>
                          <a:effectLst/>
                          <a:latin typeface="Symbol" panose="05050102010706020507" pitchFamily="18" charset="2"/>
                          <a:ea typeface="+mn-ea"/>
                          <a:cs typeface="+mn-cs"/>
                          <a:sym typeface="Symbol" panose="05050102010706020507" pitchFamily="18" charset="2"/>
                        </a:rPr>
                        <a:t></a:t>
                      </a:r>
                      <a:r>
                        <a:rPr lang="en-US" sz="1600" cap="all" baseline="0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m)</a:t>
                      </a:r>
                      <a:endParaRPr lang="fr-FR" sz="16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74755" marR="74755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fr-FR" sz="1600" dirty="0" smtClean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COLLAGEN</a:t>
                      </a:r>
                      <a:r>
                        <a:rPr lang="fr-FR" sz="1600" baseline="0" dirty="0" smtClean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FIBER LENGTH </a:t>
                      </a:r>
                      <a:endParaRPr lang="fr-FR" sz="16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74755" marR="74755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="" xmlns:a16="http://schemas.microsoft.com/office/drawing/2014/main" val="2950588746"/>
                  </a:ext>
                </a:extLst>
              </a:tr>
              <a:tr h="201011">
                <a:tc rowSpan="2"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600" cap="all" dirty="0">
                          <a:solidFill>
                            <a:schemeClr val="tx1"/>
                          </a:solidFill>
                          <a:effectLst/>
                        </a:rPr>
                        <a:t>EGI-1</a:t>
                      </a:r>
                      <a:endParaRPr lang="fr-FR" sz="16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74755" marR="74755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fr-FR" sz="1600" dirty="0" smtClean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-</a:t>
                      </a:r>
                      <a:endParaRPr lang="fr-FR" sz="16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74755" marR="74755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fr-FR" sz="1600" dirty="0" smtClean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7.44 ± 2.2</a:t>
                      </a:r>
                      <a:endParaRPr lang="fr-FR" sz="16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74755" marR="74755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fr-FR" sz="1600" dirty="0" smtClean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85.9 ± 42</a:t>
                      </a:r>
                      <a:endParaRPr lang="fr-FR" sz="16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74755" marR="74755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="" xmlns:a16="http://schemas.microsoft.com/office/drawing/2014/main" val="3696163162"/>
                  </a:ext>
                </a:extLst>
              </a:tr>
              <a:tr h="208054">
                <a:tc vMerge="1"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endParaRPr lang="fr-FR" sz="11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fr-FR" sz="1600" dirty="0" smtClean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+</a:t>
                      </a:r>
                      <a:endParaRPr lang="fr-FR" sz="16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74755" marR="74755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1600" b="1" dirty="0" smtClean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6.7 ± 1.9 ***</a:t>
                      </a:r>
                    </a:p>
                  </a:txBody>
                  <a:tcPr marL="74755" marR="74755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fr-FR" sz="1600" dirty="0" smtClean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87.8 ± 42</a:t>
                      </a:r>
                      <a:endParaRPr lang="fr-FR" sz="16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74755" marR="74755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="" xmlns:a16="http://schemas.microsoft.com/office/drawing/2014/main" val="151982917"/>
                  </a:ext>
                </a:extLst>
              </a:tr>
              <a:tr h="208054">
                <a:tc rowSpan="2"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fr-FR" sz="1600" dirty="0" smtClean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KPC</a:t>
                      </a:r>
                      <a:endParaRPr lang="fr-FR" sz="16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74755" marR="74755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600" dirty="0" smtClean="0"/>
                        <a:t>-</a:t>
                      </a:r>
                      <a:endParaRPr lang="fr-FR" sz="1600" dirty="0"/>
                    </a:p>
                  </a:txBody>
                  <a:tcPr marL="74755" marR="74755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1600" dirty="0" smtClean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4.48</a:t>
                      </a:r>
                      <a:r>
                        <a:rPr lang="fr-FR" sz="1600" baseline="0" dirty="0" smtClean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fr-FR" sz="1600" dirty="0" smtClean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± 0.9</a:t>
                      </a:r>
                    </a:p>
                  </a:txBody>
                  <a:tcPr marL="74755" marR="74755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1600" dirty="0" smtClean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67.1 ± 35</a:t>
                      </a:r>
                    </a:p>
                  </a:txBody>
                  <a:tcPr marL="74755" marR="74755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="" xmlns:a16="http://schemas.microsoft.com/office/drawing/2014/main" val="4131828804"/>
                  </a:ext>
                </a:extLst>
              </a:tr>
              <a:tr h="208054">
                <a:tc vMerge="1"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endParaRPr lang="fr-FR" sz="11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600" dirty="0" smtClean="0"/>
                        <a:t>+</a:t>
                      </a:r>
                      <a:endParaRPr lang="fr-FR" sz="1600" dirty="0"/>
                    </a:p>
                  </a:txBody>
                  <a:tcPr marL="74755" marR="74755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1600" b="1" dirty="0" smtClean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4.26 ± 0.9 ***</a:t>
                      </a:r>
                    </a:p>
                  </a:txBody>
                  <a:tcPr marL="74755" marR="74755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1600" dirty="0" smtClean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63.4 ± 30</a:t>
                      </a:r>
                    </a:p>
                  </a:txBody>
                  <a:tcPr marL="74755" marR="74755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="" xmlns:a16="http://schemas.microsoft.com/office/drawing/2014/main" val="352357140"/>
                  </a:ext>
                </a:extLst>
              </a:tr>
              <a:tr h="201011">
                <a:tc rowSpan="2"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600" cap="all" dirty="0">
                          <a:solidFill>
                            <a:schemeClr val="tx1"/>
                          </a:solidFill>
                          <a:effectLst/>
                        </a:rPr>
                        <a:t>MMTV-</a:t>
                      </a:r>
                      <a:r>
                        <a:rPr lang="en-US" sz="1600" cap="all" dirty="0" err="1">
                          <a:solidFill>
                            <a:schemeClr val="tx1"/>
                          </a:solidFill>
                          <a:effectLst/>
                        </a:rPr>
                        <a:t>PyMT</a:t>
                      </a:r>
                      <a:endParaRPr lang="fr-FR" sz="16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74755" marR="74755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fr-FR" sz="1600" dirty="0" smtClean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-</a:t>
                      </a:r>
                      <a:endParaRPr lang="fr-FR" sz="16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74755" marR="74755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1600" dirty="0" smtClean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3.66</a:t>
                      </a:r>
                      <a:r>
                        <a:rPr lang="fr-FR" sz="1600" baseline="0" dirty="0" smtClean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fr-FR" sz="1600" dirty="0" smtClean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± 1.1</a:t>
                      </a:r>
                    </a:p>
                  </a:txBody>
                  <a:tcPr marL="74755" marR="74755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fr-FR" sz="1600" dirty="0" smtClean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83.8 ± 41</a:t>
                      </a:r>
                      <a:endParaRPr lang="fr-FR" sz="16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74755" marR="74755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="" xmlns:a16="http://schemas.microsoft.com/office/drawing/2014/main" val="3352303173"/>
                  </a:ext>
                </a:extLst>
              </a:tr>
              <a:tr h="201011">
                <a:tc vMerge="1"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endParaRPr lang="fr-FR" sz="11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600" dirty="0" smtClean="0"/>
                        <a:t>+</a:t>
                      </a:r>
                      <a:endParaRPr lang="fr-FR" sz="1600" dirty="0"/>
                    </a:p>
                  </a:txBody>
                  <a:tcPr marL="74755" marR="74755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1600" dirty="0" smtClean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3.67</a:t>
                      </a:r>
                      <a:r>
                        <a:rPr lang="fr-FR" sz="1600" baseline="0" dirty="0" smtClean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fr-FR" sz="1600" dirty="0" smtClean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± 0.8</a:t>
                      </a:r>
                    </a:p>
                  </a:txBody>
                  <a:tcPr marL="74755" marR="74755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1600" dirty="0" smtClean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84.5 ± 39</a:t>
                      </a:r>
                    </a:p>
                  </a:txBody>
                  <a:tcPr marL="74755" marR="74755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="" xmlns:a16="http://schemas.microsoft.com/office/drawing/2014/main" val="148539238"/>
                  </a:ext>
                </a:extLst>
              </a:tr>
              <a:tr h="201011">
                <a:tc rowSpan="2"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600" cap="all" dirty="0" err="1">
                          <a:solidFill>
                            <a:schemeClr val="tx1"/>
                          </a:solidFill>
                          <a:effectLst/>
                        </a:rPr>
                        <a:t>m</a:t>
                      </a:r>
                      <a:r>
                        <a:rPr lang="en-US" sz="1600" cap="all" dirty="0" err="1" smtClean="0">
                          <a:solidFill>
                            <a:schemeClr val="tx1"/>
                          </a:solidFill>
                          <a:effectLst/>
                        </a:rPr>
                        <a:t>PDAC</a:t>
                      </a:r>
                      <a:endParaRPr lang="fr-FR" sz="16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74755" marR="74755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600" dirty="0" smtClean="0"/>
                        <a:t>-</a:t>
                      </a:r>
                      <a:endParaRPr lang="fr-FR" sz="1600" dirty="0"/>
                    </a:p>
                  </a:txBody>
                  <a:tcPr marL="74755" marR="74755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fr-FR" sz="1600" dirty="0" smtClean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3.49 ± 0.8</a:t>
                      </a:r>
                      <a:endParaRPr lang="fr-FR" sz="16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74755" marR="74755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1600" dirty="0" smtClean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81.5 ± 38</a:t>
                      </a:r>
                    </a:p>
                  </a:txBody>
                  <a:tcPr marL="74755" marR="74755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="" xmlns:a16="http://schemas.microsoft.com/office/drawing/2014/main" val="2207678492"/>
                  </a:ext>
                </a:extLst>
              </a:tr>
              <a:tr h="201011">
                <a:tc vMerge="1"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endParaRPr lang="fr-FR" sz="11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fr-FR" sz="1600" dirty="0" smtClean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+</a:t>
                      </a:r>
                      <a:endParaRPr lang="fr-FR" sz="16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74755" marR="74755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1600" b="1" dirty="0" smtClean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3.34 ± 0.7 ***</a:t>
                      </a:r>
                    </a:p>
                  </a:txBody>
                  <a:tcPr marL="74755" marR="74755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fr-FR" sz="1600" dirty="0" smtClean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79.6 ± 30</a:t>
                      </a:r>
                      <a:endParaRPr lang="fr-FR" sz="16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74755" marR="74755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="" xmlns:a16="http://schemas.microsoft.com/office/drawing/2014/main" val="2639204633"/>
                  </a:ext>
                </a:extLst>
              </a:tr>
            </a:tbl>
          </a:graphicData>
        </a:graphic>
      </p:graphicFrame>
      <p:sp>
        <p:nvSpPr>
          <p:cNvPr id="5" name="ZoneTexte 4"/>
          <p:cNvSpPr txBox="1"/>
          <p:nvPr/>
        </p:nvSpPr>
        <p:spPr>
          <a:xfrm>
            <a:off x="1240325" y="715224"/>
            <a:ext cx="21285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 err="1" smtClean="0"/>
              <a:t>Supplementary</a:t>
            </a:r>
            <a:r>
              <a:rPr lang="fr-FR" dirty="0" smtClean="0"/>
              <a:t> file 3</a:t>
            </a:r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307330393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=""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=""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769</TotalTime>
  <Words>78</Words>
  <Application>Microsoft Office PowerPoint</Application>
  <PresentationFormat>Personnalisé</PresentationFormat>
  <Paragraphs>33</Paragraphs>
  <Slides>1</Slides>
  <Notes>0</Notes>
  <HiddenSlides>0</HiddenSlides>
  <MMClips>0</MMClips>
  <ScaleCrop>false</ScaleCrop>
  <HeadingPairs>
    <vt:vector size="4" baseType="variant"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2" baseType="lpstr">
      <vt:lpstr>Thème Office</vt:lpstr>
      <vt:lpstr>Présentation PowerPoint</vt:lpstr>
    </vt:vector>
  </TitlesOfParts>
  <Company>Hewlett-Packard Company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Alba Nicolas-Boluda</dc:creator>
  <cp:lastModifiedBy>Emmanuel Donnadieu</cp:lastModifiedBy>
  <cp:revision>18</cp:revision>
  <dcterms:created xsi:type="dcterms:W3CDTF">2021-04-21T20:46:35Z</dcterms:created>
  <dcterms:modified xsi:type="dcterms:W3CDTF">2021-06-01T16:26:43Z</dcterms:modified>
</cp:coreProperties>
</file>